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906000" type="A4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B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04" autoAdjust="0"/>
    <p:restoredTop sz="94660"/>
  </p:normalViewPr>
  <p:slideViewPr>
    <p:cSldViewPr snapToGrid="0" showGuides="1">
      <p:cViewPr varScale="1">
        <p:scale>
          <a:sx n="39" d="100"/>
          <a:sy n="39" d="100"/>
        </p:scale>
        <p:origin x="2188" y="28"/>
      </p:cViewPr>
      <p:guideLst>
        <p:guide orient="horz" pos="55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126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830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769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562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5788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274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2511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907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637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370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30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BD6B7-B71D-40A3-952B-C965DE411071}" type="datetimeFigureOut">
              <a:rPr kumimoji="1" lang="ja-JP" altLang="en-US" smtClean="0"/>
              <a:t>2022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61DD3-0CA4-4136-9A76-F60FB19C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4966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package" Target="../embeddings/Microsoft_Excel_Worksheet1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="" xmlns:a16="http://schemas.microsoft.com/office/drawing/2014/main" id="{042F64D5-9DE3-6281-2B13-DD919FFF0442}"/>
              </a:ext>
            </a:extLst>
          </p:cNvPr>
          <p:cNvSpPr txBox="1"/>
          <p:nvPr/>
        </p:nvSpPr>
        <p:spPr>
          <a:xfrm>
            <a:off x="3911750" y="6938089"/>
            <a:ext cx="2156308" cy="3134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2" algn="ctr">
              <a:buSzPct val="175000"/>
            </a:pPr>
            <a:r>
              <a:rPr lang="en-US" altLang="ja-JP" sz="1600" dirty="0">
                <a:cs typeface="Times New Roman" pitchFamily="18" charset="0"/>
              </a:rPr>
              <a:t>: site of point mutation</a:t>
            </a:r>
          </a:p>
        </p:txBody>
      </p:sp>
      <p:graphicFrame>
        <p:nvGraphicFramePr>
          <p:cNvPr id="18" name="オブジェクト 17">
            <a:extLst>
              <a:ext uri="{FF2B5EF4-FFF2-40B4-BE49-F238E27FC236}">
                <a16:creationId xmlns="" xmlns:a16="http://schemas.microsoft.com/office/drawing/2014/main" id="{2B10BFE1-9C54-3EBF-EB4F-8223072B06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7115827"/>
              </p:ext>
            </p:extLst>
          </p:nvPr>
        </p:nvGraphicFramePr>
        <p:xfrm>
          <a:off x="1018541" y="505338"/>
          <a:ext cx="4832762" cy="64221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1" name="Worksheet" r:id="rId4" imgW="30232616" imgH="40157479" progId="Excel.Sheet.12">
                  <p:embed/>
                </p:oleObj>
              </mc:Choice>
              <mc:Fallback>
                <p:oleObj name="Worksheet" r:id="rId4" imgW="30232616" imgH="40157479" progId="Excel.Sheet.12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="" xmlns:a16="http://schemas.microsoft.com/office/drawing/2014/main" id="{AC8E0EFC-AA2C-458D-5CFD-0825BF84A0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18541" y="505338"/>
                        <a:ext cx="4832762" cy="64221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テキスト ボックス 13">
            <a:extLst>
              <a:ext uri="{FF2B5EF4-FFF2-40B4-BE49-F238E27FC236}">
                <a16:creationId xmlns="" xmlns:a16="http://schemas.microsoft.com/office/drawing/2014/main" id="{A69183C7-835B-86E1-A71C-D539D81B445A}"/>
              </a:ext>
            </a:extLst>
          </p:cNvPr>
          <p:cNvSpPr txBox="1"/>
          <p:nvPr/>
        </p:nvSpPr>
        <p:spPr>
          <a:xfrm>
            <a:off x="2119749" y="9302597"/>
            <a:ext cx="26197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2" algn="ctr">
              <a:buSzPct val="175000"/>
            </a:pPr>
            <a:r>
              <a:rPr lang="en-US" altLang="ja-JP" sz="3200" i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</a:p>
        </p:txBody>
      </p:sp>
      <p:sp>
        <p:nvSpPr>
          <p:cNvPr id="20" name="テキスト ボックス 17">
            <a:extLst>
              <a:ext uri="{FF2B5EF4-FFF2-40B4-BE49-F238E27FC236}">
                <a16:creationId xmlns="" xmlns:a16="http://schemas.microsoft.com/office/drawing/2014/main" id="{12F6DB07-794F-69C7-136F-EC319006CF23}"/>
              </a:ext>
            </a:extLst>
          </p:cNvPr>
          <p:cNvSpPr txBox="1"/>
          <p:nvPr/>
        </p:nvSpPr>
        <p:spPr>
          <a:xfrm>
            <a:off x="324642" y="7290057"/>
            <a:ext cx="6210000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ultiple sequence alignment and secondary structure elements assignment. Amino acid sequences for EAAT1 (D26443.1), EAAT2 (D85884.1), and P.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orikoshii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GltPh (NP_143181) are shown. Multiple sequences were automatically aligned using ClustalW2 (http://www.ebi.ac.uk/Tools/msa/clustalw2/) software and secondary structure elements are marked based on the crystal structure of GltPh [PDB 2NWX]. Green lines above the sequences indicate 8 transmembrane regions (TM1-8) and two re-entrant hairpin loops (HP1 and HP2). Conserved amino acid residues are shown on a black background. Twelve amino acid residues reported to be involved in the lipid pocket of GltPh in OFS (41) are shown on pink backgrounds.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ack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rrowheads indicate amino acid residues mutated in this study.</a:t>
            </a:r>
          </a:p>
        </p:txBody>
      </p:sp>
      <p:sp>
        <p:nvSpPr>
          <p:cNvPr id="21" name="テキスト ボックス 26">
            <a:extLst>
              <a:ext uri="{FF2B5EF4-FFF2-40B4-BE49-F238E27FC236}">
                <a16:creationId xmlns="" xmlns:a16="http://schemas.microsoft.com/office/drawing/2014/main" id="{8487A637-AB45-3B6E-A9E2-9ACC8E2A3FE2}"/>
              </a:ext>
            </a:extLst>
          </p:cNvPr>
          <p:cNvSpPr txBox="1"/>
          <p:nvPr/>
        </p:nvSpPr>
        <p:spPr>
          <a:xfrm>
            <a:off x="6216300" y="9425708"/>
            <a:ext cx="549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2" algn="ctr">
              <a:buSzPct val="175000"/>
            </a:pPr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S-3</a:t>
            </a:r>
          </a:p>
        </p:txBody>
      </p:sp>
      <p:sp>
        <p:nvSpPr>
          <p:cNvPr id="22" name="二等辺三角形 21">
            <a:extLst>
              <a:ext uri="{FF2B5EF4-FFF2-40B4-BE49-F238E27FC236}">
                <a16:creationId xmlns="" xmlns:a16="http://schemas.microsoft.com/office/drawing/2014/main" id="{C898DB78-9DFC-1780-1A16-50F24A7A0F9A}"/>
              </a:ext>
            </a:extLst>
          </p:cNvPr>
          <p:cNvSpPr>
            <a:spLocks noChangeAspect="1"/>
          </p:cNvSpPr>
          <p:nvPr/>
        </p:nvSpPr>
        <p:spPr>
          <a:xfrm rot="10800000" flipH="1" flipV="1">
            <a:off x="3892490" y="6970217"/>
            <a:ext cx="82858" cy="248572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3048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74</TotalTime>
  <Words>140</Words>
  <Application>Microsoft Office PowerPoint</Application>
  <PresentationFormat>A4 210 x 297 mm</PresentationFormat>
  <Paragraphs>4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Worksheet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ASHI kanako</dc:creator>
  <cp:lastModifiedBy>佐藤薫</cp:lastModifiedBy>
  <cp:revision>38</cp:revision>
  <cp:lastPrinted>2022-10-31T06:21:13Z</cp:lastPrinted>
  <dcterms:created xsi:type="dcterms:W3CDTF">2022-10-07T06:32:41Z</dcterms:created>
  <dcterms:modified xsi:type="dcterms:W3CDTF">2022-12-28T06:58:40Z</dcterms:modified>
</cp:coreProperties>
</file>